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C97F50-9823-4F12-B455-DD484A575C9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489A70-07EF-4F3E-BF63-4077AA66870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975A7D-CAB0-4686-B0C3-0963007A821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2B68F0-DA83-4FBA-B461-BEAA901E821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A4F9E1-EFFE-4006-B6C0-E8484A75DB0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2A44EF-FE4A-4EFF-941F-333A31BD79E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F40330-D3CB-43D1-871E-BF030680DE0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DCD24A-19A1-4CA1-90FD-D086006AE56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ACC626-6D05-4ED7-9115-EE10EE3A7BE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BDFE6E-08D9-4AEF-9FA7-325A9C8999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8D2A5D-8A02-48F6-BDC9-615518D9F6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9C849D-F407-4F63-A539-C4FF6957437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90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90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90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EDEDBE7-6859-4295-9B2E-10CCCC678A82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5"/>
          <p:cNvSpPr/>
          <p:nvPr/>
        </p:nvSpPr>
        <p:spPr>
          <a:xfrm>
            <a:off x="3467160" y="568440"/>
            <a:ext cx="771480" cy="372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Arial Narrow"/>
              </a:rPr>
              <a:t>ST-mRF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22"/>
          <p:cNvSpPr/>
          <p:nvPr/>
        </p:nvSpPr>
        <p:spPr>
          <a:xfrm>
            <a:off x="1430280" y="608040"/>
            <a:ext cx="123840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 Narrow"/>
              </a:rPr>
              <a:t>mRFP-HDE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41"/>
          <p:cNvSpPr/>
          <p:nvPr/>
        </p:nvSpPr>
        <p:spPr>
          <a:xfrm>
            <a:off x="-74520" y="1444680"/>
            <a:ext cx="1353960" cy="70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 Narrow"/>
              </a:rPr>
              <a:t>R/L</a:t>
            </a:r>
            <a:r>
              <a:rPr b="1" lang="fr-FR" sz="1000" spc="-1" strike="noStrike" baseline="-25000">
                <a:solidFill>
                  <a:srgbClr val="000000"/>
                </a:solidFill>
                <a:latin typeface="Arial Narrow"/>
              </a:rPr>
              <a:t>6-12</a:t>
            </a:r>
            <a:r>
              <a:rPr b="1" lang="fr-FR" sz="1000" spc="-1" strike="noStrike">
                <a:solidFill>
                  <a:srgbClr val="000000"/>
                </a:solidFill>
                <a:latin typeface="Arial Narrow"/>
              </a:rPr>
              <a:t> GCS9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 Narrow"/>
              </a:rPr>
              <a:t>LRXXRXL moti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42"/>
          <p:cNvSpPr/>
          <p:nvPr/>
        </p:nvSpPr>
        <p:spPr>
          <a:xfrm>
            <a:off x="-74520" y="5281560"/>
            <a:ext cx="1353960" cy="70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 Narrow"/>
              </a:rPr>
              <a:t>R/L</a:t>
            </a:r>
            <a:r>
              <a:rPr b="1" lang="fr-FR" sz="1000" spc="-1" strike="noStrike" baseline="-25000">
                <a:solidFill>
                  <a:srgbClr val="000000"/>
                </a:solidFill>
                <a:latin typeface="Arial Narrow"/>
              </a:rPr>
              <a:t>7-12</a:t>
            </a:r>
            <a:r>
              <a:rPr b="1" lang="fr-FR" sz="1000" spc="-1" strike="noStrike">
                <a:solidFill>
                  <a:srgbClr val="000000"/>
                </a:solidFill>
                <a:latin typeface="Arial Narrow"/>
              </a:rPr>
              <a:t> GCS9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 Narrow"/>
              </a:rPr>
              <a:t>RLXXRXL moti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43"/>
          <p:cNvSpPr/>
          <p:nvPr/>
        </p:nvSpPr>
        <p:spPr>
          <a:xfrm>
            <a:off x="-74520" y="3373560"/>
            <a:ext cx="1353960" cy="70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 Narrow"/>
              </a:rPr>
              <a:t>R/L</a:t>
            </a:r>
            <a:r>
              <a:rPr b="1" lang="fr-FR" sz="1000" spc="-1" strike="noStrike" baseline="-25000">
                <a:solidFill>
                  <a:srgbClr val="000000"/>
                </a:solidFill>
                <a:latin typeface="Arial Narrow"/>
              </a:rPr>
              <a:t>6-10</a:t>
            </a:r>
            <a:r>
              <a:rPr b="1" lang="fr-FR" sz="1000" spc="-1" strike="noStrike">
                <a:solidFill>
                  <a:srgbClr val="000000"/>
                </a:solidFill>
                <a:latin typeface="Arial Narrow"/>
              </a:rPr>
              <a:t> GCS9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 Narrow"/>
              </a:rPr>
              <a:t>LRXXLXR moti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44"/>
          <p:cNvSpPr/>
          <p:nvPr/>
        </p:nvSpPr>
        <p:spPr>
          <a:xfrm>
            <a:off x="-74520" y="6986520"/>
            <a:ext cx="1353960" cy="708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 Narrow"/>
              </a:rPr>
              <a:t>R/L</a:t>
            </a:r>
            <a:r>
              <a:rPr b="1" lang="fr-FR" sz="1000" spc="-1" strike="noStrike" baseline="-25000">
                <a:solidFill>
                  <a:srgbClr val="000000"/>
                </a:solidFill>
                <a:latin typeface="Arial Narrow"/>
              </a:rPr>
              <a:t>7-10</a:t>
            </a:r>
            <a:r>
              <a:rPr b="1" lang="fr-FR" sz="1000" spc="-1" strike="noStrike">
                <a:solidFill>
                  <a:srgbClr val="000000"/>
                </a:solidFill>
                <a:latin typeface="Arial Narrow"/>
              </a:rPr>
              <a:t> GCS9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 Narrow"/>
              </a:rPr>
              <a:t>RLXXLXR moti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Picture 55" descr="R7R12GCS90+ST52R_Overlay_00"/>
          <p:cNvPicPr/>
          <p:nvPr/>
        </p:nvPicPr>
        <p:blipFill>
          <a:blip r:embed="rId1"/>
          <a:srcRect l="2326" t="0" r="13921" b="11595"/>
          <a:stretch/>
        </p:blipFill>
        <p:spPr>
          <a:xfrm>
            <a:off x="3011400" y="4678200"/>
            <a:ext cx="1719360" cy="181476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54" descr="R7R12GCS90+HDEL-R_Overlay_13CB"/>
          <p:cNvPicPr/>
          <p:nvPr/>
        </p:nvPicPr>
        <p:blipFill>
          <a:blip r:embed="rId2"/>
          <a:srcRect l="5460" t="0" r="5460" b="5460"/>
          <a:stretch/>
        </p:blipFill>
        <p:spPr>
          <a:xfrm>
            <a:off x="1211400" y="4678200"/>
            <a:ext cx="1709640" cy="1814760"/>
          </a:xfrm>
          <a:prstGeom prst="rect">
            <a:avLst/>
          </a:prstGeom>
          <a:ln w="0">
            <a:noFill/>
          </a:ln>
        </p:spPr>
      </p:pic>
      <p:grpSp>
        <p:nvGrpSpPr>
          <p:cNvPr id="49" name="Group 2"/>
          <p:cNvGrpSpPr/>
          <p:nvPr/>
        </p:nvGrpSpPr>
        <p:grpSpPr>
          <a:xfrm>
            <a:off x="3011400" y="2790720"/>
            <a:ext cx="1712520" cy="1820520"/>
            <a:chOff x="3011400" y="2790720"/>
            <a:chExt cx="1712520" cy="1820520"/>
          </a:xfrm>
        </p:grpSpPr>
        <p:pic>
          <p:nvPicPr>
            <p:cNvPr id="50" name="Picture 3" descr="2_Snapshot_00"/>
            <p:cNvPicPr/>
            <p:nvPr/>
          </p:nvPicPr>
          <p:blipFill>
            <a:blip r:embed="rId3"/>
            <a:stretch/>
          </p:blipFill>
          <p:spPr>
            <a:xfrm>
              <a:off x="3011400" y="2790720"/>
              <a:ext cx="1712520" cy="1820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1" name="Line 4"/>
            <p:cNvSpPr/>
            <p:nvPr/>
          </p:nvSpPr>
          <p:spPr>
            <a:xfrm>
              <a:off x="4298760" y="4554720"/>
              <a:ext cx="39096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2" name="Group 7"/>
          <p:cNvGrpSpPr/>
          <p:nvPr/>
        </p:nvGrpSpPr>
        <p:grpSpPr>
          <a:xfrm>
            <a:off x="3011400" y="927000"/>
            <a:ext cx="1712520" cy="1816920"/>
            <a:chOff x="3011400" y="927000"/>
            <a:chExt cx="1712520" cy="1816920"/>
          </a:xfrm>
        </p:grpSpPr>
        <p:pic>
          <p:nvPicPr>
            <p:cNvPr id="53" name="Picture 8" descr="4_Snapshot_03"/>
            <p:cNvPicPr/>
            <p:nvPr/>
          </p:nvPicPr>
          <p:blipFill>
            <a:blip r:embed="rId4">
              <a:lum bright="6000"/>
            </a:blip>
            <a:stretch/>
          </p:blipFill>
          <p:spPr>
            <a:xfrm>
              <a:off x="3011400" y="927000"/>
              <a:ext cx="1712520" cy="1816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4" name="Line 9"/>
            <p:cNvSpPr/>
            <p:nvPr/>
          </p:nvSpPr>
          <p:spPr>
            <a:xfrm>
              <a:off x="4393080" y="2690280"/>
              <a:ext cx="28620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5" name="Group 11"/>
          <p:cNvGrpSpPr/>
          <p:nvPr/>
        </p:nvGrpSpPr>
        <p:grpSpPr>
          <a:xfrm>
            <a:off x="3011400" y="6546960"/>
            <a:ext cx="1709640" cy="1818720"/>
            <a:chOff x="3011400" y="6546960"/>
            <a:chExt cx="1709640" cy="1818720"/>
          </a:xfrm>
        </p:grpSpPr>
        <p:pic>
          <p:nvPicPr>
            <p:cNvPr id="56" name="Picture 12" descr="6_Snapshot_00"/>
            <p:cNvPicPr/>
            <p:nvPr/>
          </p:nvPicPr>
          <p:blipFill>
            <a:blip r:embed="rId5"/>
            <a:stretch/>
          </p:blipFill>
          <p:spPr>
            <a:xfrm>
              <a:off x="3011400" y="6546960"/>
              <a:ext cx="1709640" cy="1818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7" name="Line 13"/>
            <p:cNvSpPr/>
            <p:nvPr/>
          </p:nvSpPr>
          <p:spPr>
            <a:xfrm>
              <a:off x="4259520" y="8300520"/>
              <a:ext cx="39492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8" name="Group 19"/>
          <p:cNvGrpSpPr/>
          <p:nvPr/>
        </p:nvGrpSpPr>
        <p:grpSpPr>
          <a:xfrm>
            <a:off x="1209600" y="927000"/>
            <a:ext cx="1713960" cy="1816920"/>
            <a:chOff x="1209600" y="927000"/>
            <a:chExt cx="1713960" cy="1816920"/>
          </a:xfrm>
        </p:grpSpPr>
        <p:pic>
          <p:nvPicPr>
            <p:cNvPr id="59" name="Picture 20" descr="3_Snapshot_00"/>
            <p:cNvPicPr/>
            <p:nvPr/>
          </p:nvPicPr>
          <p:blipFill>
            <a:blip r:embed="rId6">
              <a:lum bright="6000"/>
            </a:blip>
            <a:stretch/>
          </p:blipFill>
          <p:spPr>
            <a:xfrm>
              <a:off x="1209600" y="927000"/>
              <a:ext cx="1713960" cy="1816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0" name="Line 21"/>
            <p:cNvSpPr/>
            <p:nvPr/>
          </p:nvSpPr>
          <p:spPr>
            <a:xfrm>
              <a:off x="2545920" y="2638440"/>
              <a:ext cx="30888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1" name="Group 23"/>
          <p:cNvGrpSpPr/>
          <p:nvPr/>
        </p:nvGrpSpPr>
        <p:grpSpPr>
          <a:xfrm>
            <a:off x="1209600" y="6546960"/>
            <a:ext cx="1714320" cy="1818720"/>
            <a:chOff x="1209600" y="6546960"/>
            <a:chExt cx="1714320" cy="1818720"/>
          </a:xfrm>
        </p:grpSpPr>
        <p:pic>
          <p:nvPicPr>
            <p:cNvPr id="62" name="Picture 24" descr="5_Snapshot_01"/>
            <p:cNvPicPr/>
            <p:nvPr/>
          </p:nvPicPr>
          <p:blipFill>
            <a:blip r:embed="rId7"/>
            <a:stretch/>
          </p:blipFill>
          <p:spPr>
            <a:xfrm>
              <a:off x="1209600" y="6546960"/>
              <a:ext cx="1714320" cy="1818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3" name="Line 25"/>
            <p:cNvSpPr/>
            <p:nvPr/>
          </p:nvSpPr>
          <p:spPr>
            <a:xfrm>
              <a:off x="2516760" y="8285760"/>
              <a:ext cx="35424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4" name="Line 28"/>
          <p:cNvSpPr/>
          <p:nvPr/>
        </p:nvSpPr>
        <p:spPr>
          <a:xfrm>
            <a:off x="2570040" y="6437160"/>
            <a:ext cx="312840" cy="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5" name="Group 29"/>
          <p:cNvGrpSpPr/>
          <p:nvPr/>
        </p:nvGrpSpPr>
        <p:grpSpPr>
          <a:xfrm>
            <a:off x="1209600" y="2790720"/>
            <a:ext cx="1713960" cy="1820160"/>
            <a:chOff x="1209600" y="2790720"/>
            <a:chExt cx="1713960" cy="1820160"/>
          </a:xfrm>
        </p:grpSpPr>
        <p:pic>
          <p:nvPicPr>
            <p:cNvPr id="66" name="Picture 30" descr="1_Snapshot_01"/>
            <p:cNvPicPr/>
            <p:nvPr/>
          </p:nvPicPr>
          <p:blipFill>
            <a:blip r:embed="rId8"/>
            <a:stretch/>
          </p:blipFill>
          <p:spPr>
            <a:xfrm>
              <a:off x="1209600" y="2790720"/>
              <a:ext cx="1713960" cy="1820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7" name="Line 31"/>
            <p:cNvSpPr/>
            <p:nvPr/>
          </p:nvSpPr>
          <p:spPr>
            <a:xfrm>
              <a:off x="2559240" y="4559760"/>
              <a:ext cx="31284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8" name="Text Box 32"/>
          <p:cNvSpPr/>
          <p:nvPr/>
        </p:nvSpPr>
        <p:spPr>
          <a:xfrm>
            <a:off x="1207080" y="934920"/>
            <a:ext cx="247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ffff"/>
                </a:solidFill>
                <a:latin typeface="Arial Narrow"/>
              </a:rPr>
              <a:t>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33"/>
          <p:cNvSpPr/>
          <p:nvPr/>
        </p:nvSpPr>
        <p:spPr>
          <a:xfrm>
            <a:off x="3012120" y="934920"/>
            <a:ext cx="247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ffff"/>
                </a:solidFill>
                <a:latin typeface="Arial Narrow"/>
              </a:rPr>
              <a:t>B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36"/>
          <p:cNvSpPr/>
          <p:nvPr/>
        </p:nvSpPr>
        <p:spPr>
          <a:xfrm>
            <a:off x="1220400" y="4665600"/>
            <a:ext cx="2433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ffffff"/>
                </a:solidFill>
                <a:latin typeface="Arial Narrow"/>
              </a:rPr>
              <a:t>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37"/>
          <p:cNvSpPr/>
          <p:nvPr/>
        </p:nvSpPr>
        <p:spPr>
          <a:xfrm>
            <a:off x="3011040" y="4665600"/>
            <a:ext cx="238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ffffff"/>
                </a:solidFill>
                <a:latin typeface="Arial Narrow"/>
              </a:rPr>
              <a:t>F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38"/>
          <p:cNvSpPr/>
          <p:nvPr/>
        </p:nvSpPr>
        <p:spPr>
          <a:xfrm>
            <a:off x="1208160" y="6543720"/>
            <a:ext cx="253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ffffff"/>
                </a:solidFill>
                <a:latin typeface="Arial Narrow"/>
              </a:rPr>
              <a:t>G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39"/>
          <p:cNvSpPr/>
          <p:nvPr/>
        </p:nvSpPr>
        <p:spPr>
          <a:xfrm>
            <a:off x="3007440" y="6543720"/>
            <a:ext cx="247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ffffff"/>
                </a:solidFill>
                <a:latin typeface="Arial Narrow"/>
              </a:rPr>
              <a:t>H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34"/>
          <p:cNvSpPr/>
          <p:nvPr/>
        </p:nvSpPr>
        <p:spPr>
          <a:xfrm>
            <a:off x="1207080" y="2795760"/>
            <a:ext cx="247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ffffff"/>
                </a:solidFill>
                <a:latin typeface="Arial Narrow"/>
              </a:rPr>
              <a:t>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35"/>
          <p:cNvSpPr/>
          <p:nvPr/>
        </p:nvSpPr>
        <p:spPr>
          <a:xfrm>
            <a:off x="3002760" y="2795760"/>
            <a:ext cx="247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ffffff"/>
                </a:solidFill>
                <a:latin typeface="Arial Narrow"/>
              </a:rPr>
              <a:t>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3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0-28T13:37:03Z</dcterms:created>
  <dc:creator>GOMORD</dc:creator>
  <dc:description/>
  <dc:language>en-US</dc:language>
  <cp:lastModifiedBy>Veronique GOMORD</cp:lastModifiedBy>
  <dcterms:modified xsi:type="dcterms:W3CDTF">2009-11-18T13:35:08Z</dcterms:modified>
  <cp:revision>37</cp:revision>
  <dc:subject/>
  <dc:title>Diapositive 1</dc:title>
</cp:coreProperties>
</file>